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pct" ContentType="image/x-pict"/>
  <Override PartName="/ppt/media/image4.png" ContentType="image/png"/>
  <Override PartName="/ppt/media/image2.png" ContentType="image/png"/>
  <Override PartName="/ppt/media/image3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C8033F-7468-460D-AF09-1EADD209B1E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B7CE8B-3694-4950-8D35-1635A55869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001FAE-764A-4F64-9554-D70D56EF128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C3399D-FD02-4931-A31F-ADB9F719168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3800EE-6310-4F8D-B7C5-2906583BB3E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772FA5-52F1-4F09-A816-40010CD0D80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3F64E1-80D9-4D85-AD09-3588B5891B8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B143F8-0E86-4B6F-BBB9-1CF85C8A88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714023-F195-4C82-B671-85FE699419F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228A31-C68A-4BFB-B077-3656A9D897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D8875B-9E9D-4831-8913-CF1B258D51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322EAD-1ECA-482F-9493-69CB8CAE00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3BCACC4-BEDF-45C3-A5D5-54A9D6655F30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0D7AF4B-118B-40AC-A31B-F536323E8242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pct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6027840" y="3852720"/>
          <a:ext cx="3019320" cy="221004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027840" y="3852720"/>
                    <a:ext cx="3019320" cy="2210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TextBox 58"/>
          <p:cNvSpPr/>
          <p:nvPr/>
        </p:nvSpPr>
        <p:spPr>
          <a:xfrm>
            <a:off x="5508000" y="0"/>
            <a:ext cx="3638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Bush, et al., Supplemental Figure S5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45"/>
          <p:cNvSpPr/>
          <p:nvPr/>
        </p:nvSpPr>
        <p:spPr>
          <a:xfrm>
            <a:off x="297000" y="5977080"/>
            <a:ext cx="87516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ure S5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. (A) Total RNA levels in WT and KO MEFs, (B) qPCR validation of genes downregulated on microarray (C) Histone genes with upregulated expression in constitutive KO – array data. D) Immunoblots of histone H2b and H4. (E) Western blot and associated quantification of CENP-A protein in KO 49 and 52 vs. Mean W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34"/>
          <p:cNvSpPr/>
          <p:nvPr/>
        </p:nvSpPr>
        <p:spPr>
          <a:xfrm>
            <a:off x="204840" y="3127320"/>
            <a:ext cx="183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Chart 31" descr=""/>
          <p:cNvPicPr/>
          <p:nvPr/>
        </p:nvPicPr>
        <p:blipFill>
          <a:blip r:embed="rId3"/>
          <a:stretch/>
        </p:blipFill>
        <p:spPr>
          <a:xfrm>
            <a:off x="0" y="0"/>
            <a:ext cx="3919680" cy="2919240"/>
          </a:xfrm>
          <a:prstGeom prst="rect">
            <a:avLst/>
          </a:prstGeom>
          <a:ln w="0">
            <a:noFill/>
          </a:ln>
        </p:spPr>
      </p:pic>
      <p:sp>
        <p:nvSpPr>
          <p:cNvPr id="47" name="TextBox 34"/>
          <p:cNvSpPr/>
          <p:nvPr/>
        </p:nvSpPr>
        <p:spPr>
          <a:xfrm>
            <a:off x="112680" y="131760"/>
            <a:ext cx="1843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34"/>
          <p:cNvSpPr/>
          <p:nvPr/>
        </p:nvSpPr>
        <p:spPr>
          <a:xfrm>
            <a:off x="3251160" y="3174840"/>
            <a:ext cx="368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36" descr="Picture 7"/>
          <p:cNvPicPr/>
          <p:nvPr/>
        </p:nvPicPr>
        <p:blipFill>
          <a:blip r:embed="rId4"/>
          <a:stretch/>
        </p:blipFill>
        <p:spPr>
          <a:xfrm>
            <a:off x="3102120" y="3749760"/>
            <a:ext cx="2739960" cy="1762200"/>
          </a:xfrm>
          <a:prstGeom prst="rect">
            <a:avLst/>
          </a:prstGeom>
          <a:ln w="0">
            <a:noFill/>
          </a:ln>
        </p:spPr>
      </p:pic>
      <p:sp>
        <p:nvSpPr>
          <p:cNvPr id="50" name="Rectangle 39"/>
          <p:cNvSpPr/>
          <p:nvPr/>
        </p:nvSpPr>
        <p:spPr>
          <a:xfrm>
            <a:off x="4184640" y="13176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40"/>
          <p:cNvSpPr/>
          <p:nvPr/>
        </p:nvSpPr>
        <p:spPr>
          <a:xfrm>
            <a:off x="5675760" y="3181320"/>
            <a:ext cx="3499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48"/>
          <p:cNvSpPr/>
          <p:nvPr/>
        </p:nvSpPr>
        <p:spPr>
          <a:xfrm>
            <a:off x="1387800" y="692280"/>
            <a:ext cx="1555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NA Levels per Cel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50"/>
          <p:cNvSpPr/>
          <p:nvPr/>
        </p:nvSpPr>
        <p:spPr>
          <a:xfrm>
            <a:off x="1635120" y="2624040"/>
            <a:ext cx="874800" cy="235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Picture 65" descr="Picture 14"/>
          <p:cNvPicPr/>
          <p:nvPr/>
        </p:nvPicPr>
        <p:blipFill>
          <a:blip r:embed="rId5"/>
          <a:stretch/>
        </p:blipFill>
        <p:spPr>
          <a:xfrm>
            <a:off x="297000" y="3624120"/>
            <a:ext cx="2862000" cy="1887840"/>
          </a:xfrm>
          <a:prstGeom prst="rect">
            <a:avLst/>
          </a:prstGeom>
          <a:ln w="0">
            <a:noFill/>
          </a:ln>
        </p:spPr>
      </p:pic>
      <p:sp>
        <p:nvSpPr>
          <p:cNvPr id="55" name="Rectangle 70"/>
          <p:cNvSpPr/>
          <p:nvPr/>
        </p:nvSpPr>
        <p:spPr>
          <a:xfrm>
            <a:off x="7135920" y="5780160"/>
            <a:ext cx="512640" cy="282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6" name="Group 73"/>
          <p:cNvGrpSpPr/>
          <p:nvPr/>
        </p:nvGrpSpPr>
        <p:grpSpPr>
          <a:xfrm>
            <a:off x="4367160" y="528480"/>
            <a:ext cx="4017960" cy="2330640"/>
            <a:chOff x="4367160" y="528480"/>
            <a:chExt cx="4017960" cy="2330640"/>
          </a:xfrm>
        </p:grpSpPr>
        <p:pic>
          <p:nvPicPr>
            <p:cNvPr id="57" name="Picture 46" descr="Picture 2"/>
            <p:cNvPicPr/>
            <p:nvPr/>
          </p:nvPicPr>
          <p:blipFill>
            <a:blip r:embed="rId6"/>
            <a:stretch/>
          </p:blipFill>
          <p:spPr>
            <a:xfrm>
              <a:off x="4367160" y="528480"/>
              <a:ext cx="4017960" cy="2330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" name="Rectangle 72"/>
            <p:cNvSpPr/>
            <p:nvPr/>
          </p:nvSpPr>
          <p:spPr>
            <a:xfrm>
              <a:off x="6153120" y="1797120"/>
              <a:ext cx="95400" cy="108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59" name="" descr=""/>
          <p:cNvPicPr/>
          <p:nvPr/>
        </p:nvPicPr>
        <p:blipFill>
          <a:blip r:embed="rId7"/>
          <a:stretch/>
        </p:blipFill>
        <p:spPr>
          <a:xfrm>
            <a:off x="6454800" y="2952720"/>
            <a:ext cx="1668600" cy="900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03T22:15:27Z</dcterms:created>
  <dc:creator>Paul Knoepfler</dc:creator>
  <dc:description/>
  <dc:language>en-US</dc:language>
  <cp:lastModifiedBy>Research User</cp:lastModifiedBy>
  <dcterms:modified xsi:type="dcterms:W3CDTF">2013-03-18T22:20:25Z</dcterms:modified>
  <cp:revision>20</cp:revision>
  <dc:subject/>
  <dc:title>Slide 1</dc:title>
</cp:coreProperties>
</file>